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60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91918" y="195496"/>
            <a:ext cx="66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S3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|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Ultrasound fetal measurements at 21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dpc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in the first generation. </a:t>
            </a:r>
            <a:endParaRPr lang="fr-FR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6" name="Tableau 5"/>
          <p:cNvGraphicFramePr>
            <a:graphicFrameLocks noGrp="1"/>
          </p:cNvGraphicFramePr>
          <p:nvPr/>
        </p:nvGraphicFramePr>
        <p:xfrm>
          <a:off x="91919" y="476672"/>
          <a:ext cx="6659999" cy="2058156"/>
        </p:xfrm>
        <a:graphic>
          <a:graphicData uri="http://schemas.openxmlformats.org/drawingml/2006/table">
            <a:tbl>
              <a:tblPr/>
              <a:tblGrid>
                <a:gridCol w="1908212"/>
                <a:gridCol w="288032"/>
                <a:gridCol w="288032"/>
                <a:gridCol w="1152128"/>
                <a:gridCol w="1152128"/>
                <a:gridCol w="504056"/>
                <a:gridCol w="864096"/>
                <a:gridCol w="503315"/>
              </a:tblGrid>
              <a:tr h="29693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ariable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umber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of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etuses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dian</a:t>
                      </a:r>
                      <a:r>
                        <a:rPr lang="fr-FR" sz="1000" b="1" i="0" u="none" strike="noStrike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[Q1; Q3]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am -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djusted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inear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model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4484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β 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alue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I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-value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844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bdominal </a:t>
                      </a:r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erimeter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mm)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8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2.85 [41.85; 43.9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2.30 [40.70; 43.95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973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2.51;0.564]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28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4844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emur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ength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mm)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9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8 [2.7; 3.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8 [2.7; 2.9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14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428;0.149]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354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844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ead </a:t>
                      </a:r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ength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mm)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8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.50 [16.75; 17.85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.10 [16.60; 17.6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279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677;0.119]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184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844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iparietal </a:t>
                      </a:r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ameter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mm)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8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.400 [9.125; 9.825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.500 [9.100; 9.875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123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582;0.336]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603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844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Umbilical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ulse (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eat/min)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5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64.0 [257.5; 270.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60.0 [256.0; 269.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1.972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8.889;4.945]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580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844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ulsatility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Index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5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770 [1.613; 1.88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770 [1.635; 1.915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016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127;0.095]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778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844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esistance Index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5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840 [0.820; 0.86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830 [0.815; 0.86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001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019;0.022]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906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844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ystolic velocity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5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.45 [12.41; 18.55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.84 [12.27; 17.29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523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2.442;1.397]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597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844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astolic velocity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5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550 [2.160; 2.94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310 [2.015; 2.99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058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429;0.313]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761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844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ystolic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/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astolic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elocity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ratio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5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.300 [5.533; 7.053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.050 [5.355; 7.16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149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61;0.907]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703</a:t>
                      </a:r>
                    </a:p>
                  </a:txBody>
                  <a:tcPr marL="11401" marR="11401" marT="641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ZoneTexte 6"/>
          <p:cNvSpPr txBox="1"/>
          <p:nvPr/>
        </p:nvSpPr>
        <p:spPr>
          <a:xfrm>
            <a:off x="91918" y="2550793"/>
            <a:ext cx="66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All data are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expresse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as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median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[Q1;Q3]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3</TotalTime>
  <Words>278</Words>
  <Application>Microsoft Office PowerPoint</Application>
  <PresentationFormat>Affichage à l'écran (4:3)</PresentationFormat>
  <Paragraphs>9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NR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valentino</dc:creator>
  <cp:lastModifiedBy>Sarah</cp:lastModifiedBy>
  <cp:revision>51</cp:revision>
  <dcterms:created xsi:type="dcterms:W3CDTF">2015-02-24T15:36:47Z</dcterms:created>
  <dcterms:modified xsi:type="dcterms:W3CDTF">2016-02-08T10:29:29Z</dcterms:modified>
</cp:coreProperties>
</file>